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6" r:id="rId3"/>
    <p:sldId id="258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5" autoAdjust="0"/>
    <p:restoredTop sz="94660"/>
  </p:normalViewPr>
  <p:slideViewPr>
    <p:cSldViewPr snapToGrid="0" showGuides="1">
      <p:cViewPr varScale="1">
        <p:scale>
          <a:sx n="71" d="100"/>
          <a:sy n="71" d="100"/>
        </p:scale>
        <p:origin x="3064" y="184"/>
      </p:cViewPr>
      <p:guideLst>
        <p:guide orient="horz" pos="3840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0B879-4F7D-4ED2-9B97-060D148D576D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C4D7-AE46-426F-9526-AA5414F5E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9680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0B879-4F7D-4ED2-9B97-060D148D576D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C4D7-AE46-426F-9526-AA5414F5E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3628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0B879-4F7D-4ED2-9B97-060D148D576D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C4D7-AE46-426F-9526-AA5414F5E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2616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0B879-4F7D-4ED2-9B97-060D148D576D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C4D7-AE46-426F-9526-AA5414F5E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3429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0B879-4F7D-4ED2-9B97-060D148D576D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C4D7-AE46-426F-9526-AA5414F5E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61370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0B879-4F7D-4ED2-9B97-060D148D576D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C4D7-AE46-426F-9526-AA5414F5E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913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0B879-4F7D-4ED2-9B97-060D148D576D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C4D7-AE46-426F-9526-AA5414F5E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1140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0B879-4F7D-4ED2-9B97-060D148D576D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C4D7-AE46-426F-9526-AA5414F5E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6016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0B879-4F7D-4ED2-9B97-060D148D576D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C4D7-AE46-426F-9526-AA5414F5E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8643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0B879-4F7D-4ED2-9B97-060D148D576D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C4D7-AE46-426F-9526-AA5414F5E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19128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0B879-4F7D-4ED2-9B97-060D148D576D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7C4D7-AE46-426F-9526-AA5414F5E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85299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00B879-4F7D-4ED2-9B97-060D148D576D}" type="datetimeFigureOut">
              <a:rPr lang="en-GB" smtClean="0"/>
              <a:t>27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C7C4D7-AE46-426F-9526-AA5414F5E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6344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5174EC8-6EFE-14A7-E919-04CC3AFD97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8121264"/>
              </p:ext>
            </p:extLst>
          </p:nvPr>
        </p:nvGraphicFramePr>
        <p:xfrm>
          <a:off x="471488" y="1378634"/>
          <a:ext cx="5750018" cy="8751482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400845">
                  <a:extLst>
                    <a:ext uri="{9D8B030D-6E8A-4147-A177-3AD203B41FA5}">
                      <a16:colId xmlns:a16="http://schemas.microsoft.com/office/drawing/2014/main" val="2125629317"/>
                    </a:ext>
                  </a:extLst>
                </a:gridCol>
                <a:gridCol w="1327008">
                  <a:extLst>
                    <a:ext uri="{9D8B030D-6E8A-4147-A177-3AD203B41FA5}">
                      <a16:colId xmlns:a16="http://schemas.microsoft.com/office/drawing/2014/main" val="1405862241"/>
                    </a:ext>
                  </a:extLst>
                </a:gridCol>
                <a:gridCol w="1548002">
                  <a:extLst>
                    <a:ext uri="{9D8B030D-6E8A-4147-A177-3AD203B41FA5}">
                      <a16:colId xmlns:a16="http://schemas.microsoft.com/office/drawing/2014/main" val="3445179685"/>
                    </a:ext>
                  </a:extLst>
                </a:gridCol>
                <a:gridCol w="1474163">
                  <a:extLst>
                    <a:ext uri="{9D8B030D-6E8A-4147-A177-3AD203B41FA5}">
                      <a16:colId xmlns:a16="http://schemas.microsoft.com/office/drawing/2014/main" val="34643018"/>
                    </a:ext>
                  </a:extLst>
                </a:gridCol>
              </a:tblGrid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b="1" dirty="0">
                          <a:effectLst/>
                        </a:rPr>
                        <a:t>Individual </a:t>
                      </a:r>
                      <a:endParaRPr lang="en-GB" sz="9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b="1" dirty="0">
                          <a:effectLst/>
                        </a:rPr>
                        <a:t>Family </a:t>
                      </a:r>
                      <a:endParaRPr lang="en-GB" sz="9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b="1" dirty="0">
                          <a:effectLst/>
                        </a:rPr>
                        <a:t>Socio-environmental</a:t>
                      </a:r>
                      <a:endParaRPr lang="en-GB" sz="9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b="1" dirty="0">
                          <a:effectLst/>
                        </a:rPr>
                        <a:t>Non-familial social networks</a:t>
                      </a:r>
                      <a:endParaRPr lang="en-GB" sz="9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4074975094"/>
                  </a:ext>
                </a:extLst>
              </a:tr>
              <a:tr h="28490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</a:rPr>
                        <a:t>Age i.e., older adolescents (29) 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Maternal education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Socio-economic status (17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Peers/Friend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3289439488"/>
                  </a:ext>
                </a:extLst>
              </a:tr>
              <a:tr h="40885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Hazardous drug (6) /alcohol use (7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Lacking parental supervision (12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Exposure to product advertisement/ promotions (14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Having friends who use substance (25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2140927456"/>
                  </a:ext>
                </a:extLst>
              </a:tr>
              <a:tr h="3782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Gender (40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Having family who use substance (25)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Liking product advertisement / promotions (11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Bullying (4)</a:t>
                      </a:r>
                      <a:endParaRPr lang="en-GB" sz="900"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396838743"/>
                  </a:ext>
                </a:extLst>
              </a:tr>
              <a:tr h="28490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Marital status (3)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Living with someone who uses substances (10)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Violence / physical abuse exposure (5)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Coerced sex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2451905713"/>
                  </a:ext>
                </a:extLst>
              </a:tr>
              <a:tr h="28490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Depression (18) and / or anxiety (10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Parental knowledge of adolescent activities (4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×Physically attacked </a:t>
                      </a:r>
                      <a:r>
                        <a:rPr lang="en-US" sz="800">
                          <a:effectLst/>
                          <a:highlight>
                            <a:srgbClr val="FFFF00"/>
                          </a:highlight>
                        </a:rPr>
                        <a:t>– group with violenc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× Number of close friends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4280976714"/>
                  </a:ext>
                </a:extLst>
              </a:tr>
              <a:tr h="54718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Suicide ideation, planning, and/or suicide attempt (6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× Negative family variables (i.e. stress, hostility, and psychological control)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Watching football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× Role model – </a:t>
                      </a:r>
                      <a:r>
                        <a:rPr lang="en-US" sz="800">
                          <a:effectLst/>
                          <a:highlight>
                            <a:srgbClr val="FFFF00"/>
                          </a:highlight>
                        </a:rPr>
                        <a:t>group with tutors/teachers?</a:t>
                      </a:r>
                      <a:r>
                        <a:rPr lang="en-US" sz="800">
                          <a:effectLst/>
                        </a:rPr>
                        <a:t>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581650356"/>
                  </a:ext>
                </a:extLst>
              </a:tr>
              <a:tr h="4305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Loneliness (4) seems a proxy for suicide ideation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Parent works at the company making the substanc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Internet access at home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School truancy (6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3116426901"/>
                  </a:ext>
                </a:extLst>
              </a:tr>
              <a:tr h="40885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Using other drugs (12)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Order of being born (first born, second born etc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Exposure to SHS (3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School suspension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1659772366"/>
                  </a:ext>
                </a:extLst>
              </a:tr>
              <a:tr h="28490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Being sexually active (7)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Loss of loved one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Offered free (3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Learning about smoking in school (5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868508777"/>
                  </a:ext>
                </a:extLst>
              </a:tr>
              <a:tr h="4305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Risky sexual behaviour – </a:t>
                      </a:r>
                      <a:r>
                        <a:rPr lang="en-US" sz="800">
                          <a:effectLst/>
                          <a:highlight>
                            <a:srgbClr val="FFFF00"/>
                          </a:highlight>
                        </a:rPr>
                        <a:t>group with ‘risky behaviour OR above?</a:t>
                      </a:r>
                      <a:r>
                        <a:rPr lang="en-US" sz="800">
                          <a:effectLst/>
                        </a:rPr>
                        <a:t>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Family type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× Availability of substance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Tutors/ teachers (3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3353144635"/>
                  </a:ext>
                </a:extLst>
              </a:tr>
              <a:tr h="40885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×Adverse childhood events </a:t>
                      </a:r>
                      <a:r>
                        <a:rPr lang="en-US" sz="800">
                          <a:effectLst/>
                          <a:highlight>
                            <a:srgbClr val="FFFF00"/>
                          </a:highlight>
                        </a:rPr>
                        <a:t>- need details on type of events</a:t>
                      </a:r>
                      <a:r>
                        <a:rPr lang="en-US" sz="800">
                          <a:effectLst/>
                        </a:rPr>
                        <a:t>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social vulnerability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Being a student (7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3494743285"/>
                  </a:ext>
                </a:extLst>
              </a:tr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Smoked cigarettes (3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Poor school performance (4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1295071538"/>
                  </a:ext>
                </a:extLst>
              </a:tr>
              <a:tr h="57627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Involved in a physical fight </a:t>
                      </a:r>
                      <a:r>
                        <a:rPr lang="en-US" sz="800">
                          <a:effectLst/>
                          <a:highlight>
                            <a:srgbClr val="FFFF00"/>
                          </a:highlight>
                        </a:rPr>
                        <a:t>– group with ‘violence’ under ‘environment’ OR ‘risky behaviour’?</a:t>
                      </a:r>
                      <a:r>
                        <a:rPr lang="en-US" sz="800">
                          <a:effectLst/>
                        </a:rPr>
                        <a:t> 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2580934381"/>
                  </a:ext>
                </a:extLst>
              </a:tr>
              <a:tr h="28490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Brain volume in left posterior cingulate cortex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410954497"/>
                  </a:ext>
                </a:extLst>
              </a:tr>
              <a:tr h="4305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Gene involved in circadian rhythm found (BHLHE41, NR1D1)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2253099151"/>
                  </a:ext>
                </a:extLst>
              </a:tr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Religion (5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1506346777"/>
                  </a:ext>
                </a:extLst>
              </a:tr>
              <a:tr h="28490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× Skin colour </a:t>
                      </a:r>
                      <a:r>
                        <a:rPr lang="en-US" sz="800">
                          <a:effectLst/>
                          <a:highlight>
                            <a:srgbClr val="FFFF00"/>
                          </a:highlight>
                        </a:rPr>
                        <a:t>– group with ethnicity</a:t>
                      </a:r>
                      <a:r>
                        <a:rPr lang="en-US" sz="800">
                          <a:effectLst/>
                        </a:rPr>
                        <a:t>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3110460131"/>
                  </a:ext>
                </a:extLst>
              </a:tr>
              <a:tr h="28490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Personal factors (i.e. self-deviance, violence, ego)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2017680731"/>
                  </a:ext>
                </a:extLst>
              </a:tr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Insomnia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1209881222"/>
                  </a:ext>
                </a:extLst>
              </a:tr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Curiosity (4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1074224702"/>
                  </a:ext>
                </a:extLst>
              </a:tr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Wanting to be free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3149204347"/>
                  </a:ext>
                </a:extLst>
              </a:tr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Pleasure/smell / taste (3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2477186684"/>
                  </a:ext>
                </a:extLst>
              </a:tr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× Risky behaviour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1594866932"/>
                  </a:ext>
                </a:extLst>
              </a:tr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Ethnicity (8)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1035507447"/>
                  </a:ext>
                </a:extLst>
              </a:tr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Beliefs (4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4095117402"/>
                  </a:ext>
                </a:extLst>
              </a:tr>
              <a:tr h="27053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Get away from other drugs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2044828000"/>
                  </a:ext>
                </a:extLst>
              </a:tr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Self-medication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2905432955"/>
                  </a:ext>
                </a:extLst>
              </a:tr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Chronic illness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2262900791"/>
                  </a:ext>
                </a:extLst>
              </a:tr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Leisure time / free time (3)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4065410277"/>
                  </a:ext>
                </a:extLst>
              </a:tr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Medical history 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1925226032"/>
                  </a:ext>
                </a:extLst>
              </a:tr>
              <a:tr h="1392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× Stimulants?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</a:rPr>
                        <a:t> </a:t>
                      </a:r>
                      <a:endParaRPr lang="en-GB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extLst>
                  <a:ext uri="{0D108BD9-81ED-4DB2-BD59-A6C34878D82A}">
                    <a16:rowId xmlns:a16="http://schemas.microsoft.com/office/drawing/2014/main" val="2135530042"/>
                  </a:ext>
                </a:extLst>
              </a:tr>
              <a:tr h="378284">
                <a:tc grid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</a:rPr>
                        <a:t>× mentioned in only 1 study </a:t>
                      </a:r>
                      <a:endParaRPr lang="en-GB" sz="900" dirty="0"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</a:rPr>
                        <a:t>×× mentioned in only 2 studies </a:t>
                      </a:r>
                      <a:endParaRPr lang="en-GB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7770" marR="5777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13838088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EF1A2E79-1361-D50E-770D-BD3984E177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1488" y="849531"/>
            <a:ext cx="6001030" cy="2616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100" b="1" dirty="0">
                <a:ea typeface="Calibri" panose="020F0502020204030204" pitchFamily="34" charset="0"/>
                <a:cs typeface="Arial" panose="020B0604020202020204" pitchFamily="34" charset="0"/>
              </a:rPr>
              <a:t>Supplementary appendix 1</a:t>
            </a: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: Coding of factors of adolescent substance use in Africa to determinants</a:t>
            </a:r>
            <a:endParaRPr kumimoji="0" lang="en-US" altLang="en-US" sz="11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9304035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53493E16-1937-4CB8-8D2D-FBCA82B15953}"/>
              </a:ext>
            </a:extLst>
          </p:cNvPr>
          <p:cNvSpPr/>
          <p:nvPr/>
        </p:nvSpPr>
        <p:spPr>
          <a:xfrm>
            <a:off x="2644107" y="958032"/>
            <a:ext cx="1442982" cy="72646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Alcohol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(9 papers)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521D602-33DA-44C2-AC29-C4002F41DBC1}"/>
              </a:ext>
            </a:extLst>
          </p:cNvPr>
          <p:cNvSpPr/>
          <p:nvPr/>
        </p:nvSpPr>
        <p:spPr>
          <a:xfrm>
            <a:off x="2644107" y="2169201"/>
            <a:ext cx="1442982" cy="108758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chemeClr val="tx1"/>
                </a:solidFill>
              </a:rPr>
              <a:t>Predictors with more than 3 papers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E669080-B796-4398-BB80-3420B6DAD8D5}"/>
              </a:ext>
            </a:extLst>
          </p:cNvPr>
          <p:cNvSpPr/>
          <p:nvPr/>
        </p:nvSpPr>
        <p:spPr>
          <a:xfrm>
            <a:off x="585049" y="3939434"/>
            <a:ext cx="1442982" cy="224398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chemeClr val="tx1"/>
                </a:solidFill>
              </a:rPr>
              <a:t>Age </a:t>
            </a:r>
          </a:p>
          <a:p>
            <a:pPr algn="ctr"/>
            <a:r>
              <a:rPr lang="en-GB" sz="1600" b="1" dirty="0">
                <a:solidFill>
                  <a:schemeClr val="tx1"/>
                </a:solidFill>
              </a:rPr>
              <a:t>7 papers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(each with different alcohol outcome)</a:t>
            </a:r>
          </a:p>
          <a:p>
            <a:pPr algn="ctr"/>
            <a:endParaRPr lang="en-GB" sz="1600" dirty="0">
              <a:solidFill>
                <a:schemeClr val="tx1"/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9CF08542-0DA0-4247-9037-5EC2FA1CD2BD}"/>
              </a:ext>
            </a:extLst>
          </p:cNvPr>
          <p:cNvSpPr/>
          <p:nvPr/>
        </p:nvSpPr>
        <p:spPr>
          <a:xfrm>
            <a:off x="2449090" y="3938186"/>
            <a:ext cx="1637999" cy="224398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 b="1" dirty="0">
              <a:solidFill>
                <a:schemeClr val="tx1"/>
              </a:solidFill>
            </a:endParaRPr>
          </a:p>
          <a:p>
            <a:pPr algn="ctr"/>
            <a:r>
              <a:rPr lang="en-GB" sz="1600" b="1" dirty="0">
                <a:solidFill>
                  <a:schemeClr val="tx1"/>
                </a:solidFill>
              </a:rPr>
              <a:t>Gender </a:t>
            </a:r>
          </a:p>
          <a:p>
            <a:pPr algn="ctr"/>
            <a:r>
              <a:rPr lang="en-GB" sz="1600" b="1" dirty="0">
                <a:solidFill>
                  <a:schemeClr val="tx1"/>
                </a:solidFill>
              </a:rPr>
              <a:t>8 papers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(2 papers with the same outcome </a:t>
            </a:r>
            <a:r>
              <a:rPr lang="en-GB" sz="1600" b="1" dirty="0">
                <a:solidFill>
                  <a:schemeClr val="tx1"/>
                </a:solidFill>
              </a:rPr>
              <a:t>alcohol use yes/no</a:t>
            </a:r>
            <a:r>
              <a:rPr lang="en-GB" sz="1600" dirty="0">
                <a:solidFill>
                  <a:schemeClr val="tx1"/>
                </a:solidFill>
              </a:rPr>
              <a:t>)</a:t>
            </a:r>
          </a:p>
          <a:p>
            <a:pPr algn="ctr"/>
            <a:endParaRPr lang="en-GB" sz="1600" dirty="0">
              <a:solidFill>
                <a:schemeClr val="tx1"/>
              </a:solidFill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80C4847-ED81-4594-9B25-43D5606BD388}"/>
              </a:ext>
            </a:extLst>
          </p:cNvPr>
          <p:cNvSpPr/>
          <p:nvPr/>
        </p:nvSpPr>
        <p:spPr>
          <a:xfrm>
            <a:off x="4461165" y="3938188"/>
            <a:ext cx="2046707" cy="224398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chemeClr val="tx1"/>
                </a:solidFill>
              </a:rPr>
              <a:t>Social economic status 3 papers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(each paper has different alcohol outcome)</a:t>
            </a:r>
          </a:p>
          <a:p>
            <a:pPr algn="ctr"/>
            <a:endParaRPr lang="en-GB" sz="1600" dirty="0">
              <a:solidFill>
                <a:schemeClr val="tx1"/>
              </a:solidFill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4E9FF92-25F0-4CD7-87EF-4A903D312504}"/>
              </a:ext>
            </a:extLst>
          </p:cNvPr>
          <p:cNvSpPr/>
          <p:nvPr/>
        </p:nvSpPr>
        <p:spPr>
          <a:xfrm>
            <a:off x="585049" y="6610273"/>
            <a:ext cx="5922823" cy="444563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chemeClr val="tx1"/>
                </a:solidFill>
              </a:rPr>
              <a:t>All Alcohol outcomes included in papers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alcohol use (yes/no) X 2 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alcohol use in the past 6 months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During the past 30 days, on how many days did you have at least one drink containing acohol30 days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Number of drinks in past 30 days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 number of times drunk in life,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number of troubles as a result of drink 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Drunk at least once (yes/No)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alcohol dose units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frequency of alcohol use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alcohol use disorder diagnosis</a:t>
            </a:r>
          </a:p>
          <a:p>
            <a:pPr algn="ctr"/>
            <a:r>
              <a:rPr lang="en-GB" sz="1600" dirty="0">
                <a:solidFill>
                  <a:schemeClr val="tx1"/>
                </a:solidFill>
              </a:rPr>
              <a:t>drunk in the past year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680603CC-EEB7-4B89-8904-51C054153ADA}"/>
              </a:ext>
            </a:extLst>
          </p:cNvPr>
          <p:cNvCxnSpPr>
            <a:stCxn id="6" idx="2"/>
            <a:endCxn id="8" idx="0"/>
          </p:cNvCxnSpPr>
          <p:nvPr/>
        </p:nvCxnSpPr>
        <p:spPr>
          <a:xfrm>
            <a:off x="3365598" y="1684492"/>
            <a:ext cx="0" cy="48470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3F69051C-8B4B-4EAC-AD8B-5F01CD209633}"/>
              </a:ext>
            </a:extLst>
          </p:cNvPr>
          <p:cNvCxnSpPr>
            <a:cxnSpLocks/>
          </p:cNvCxnSpPr>
          <p:nvPr/>
        </p:nvCxnSpPr>
        <p:spPr>
          <a:xfrm>
            <a:off x="3365598" y="3254996"/>
            <a:ext cx="0" cy="3837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5548115E-EA6D-4DA7-874D-0A37B2BE3344}"/>
              </a:ext>
            </a:extLst>
          </p:cNvPr>
          <p:cNvCxnSpPr>
            <a:cxnSpLocks/>
          </p:cNvCxnSpPr>
          <p:nvPr/>
        </p:nvCxnSpPr>
        <p:spPr>
          <a:xfrm flipH="1" flipV="1">
            <a:off x="1306540" y="3656036"/>
            <a:ext cx="4244920" cy="692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B37E41CF-0800-4D88-9DB6-F6AC23F031BC}"/>
              </a:ext>
            </a:extLst>
          </p:cNvPr>
          <p:cNvCxnSpPr>
            <a:cxnSpLocks/>
          </p:cNvCxnSpPr>
          <p:nvPr/>
        </p:nvCxnSpPr>
        <p:spPr>
          <a:xfrm>
            <a:off x="5552734" y="3661787"/>
            <a:ext cx="0" cy="27061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D906F112-AB62-469B-A8E7-6544CB3FDFBC}"/>
              </a:ext>
            </a:extLst>
          </p:cNvPr>
          <p:cNvCxnSpPr>
            <a:cxnSpLocks/>
          </p:cNvCxnSpPr>
          <p:nvPr/>
        </p:nvCxnSpPr>
        <p:spPr>
          <a:xfrm>
            <a:off x="3365598" y="3668715"/>
            <a:ext cx="0" cy="2636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92AFEED1-7A6F-43BC-99F4-4A0FFA157964}"/>
              </a:ext>
            </a:extLst>
          </p:cNvPr>
          <p:cNvCxnSpPr>
            <a:cxnSpLocks/>
            <a:endCxn id="5" idx="0"/>
          </p:cNvCxnSpPr>
          <p:nvPr/>
        </p:nvCxnSpPr>
        <p:spPr>
          <a:xfrm>
            <a:off x="1306540" y="3668819"/>
            <a:ext cx="0" cy="27061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2CE1E11A-D4B6-9C7B-C7DE-F88B4561573B}"/>
              </a:ext>
            </a:extLst>
          </p:cNvPr>
          <p:cNvSpPr txBox="1"/>
          <p:nvPr/>
        </p:nvSpPr>
        <p:spPr>
          <a:xfrm>
            <a:off x="806824" y="508180"/>
            <a:ext cx="521441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appendix 2: Predictors of adolescent alcohol use mentioned across included studies  </a:t>
            </a:r>
          </a:p>
        </p:txBody>
      </p:sp>
    </p:spTree>
    <p:extLst>
      <p:ext uri="{BB962C8B-B14F-4D97-AF65-F5344CB8AC3E}">
        <p14:creationId xmlns:p14="http://schemas.microsoft.com/office/powerpoint/2010/main" val="10474804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62E29A09-1EC8-4CFC-8814-E5432B023C17}"/>
              </a:ext>
            </a:extLst>
          </p:cNvPr>
          <p:cNvSpPr/>
          <p:nvPr/>
        </p:nvSpPr>
        <p:spPr>
          <a:xfrm>
            <a:off x="2628431" y="1685379"/>
            <a:ext cx="1442982" cy="72646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chemeClr val="tx1"/>
                </a:solidFill>
              </a:rPr>
              <a:t>Smoking</a:t>
            </a:r>
          </a:p>
          <a:p>
            <a:pPr algn="ctr"/>
            <a:r>
              <a:rPr lang="en-GB" sz="1400" dirty="0">
                <a:solidFill>
                  <a:schemeClr val="tx1"/>
                </a:solidFill>
              </a:rPr>
              <a:t>(28 papers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51FDD88-CB12-40E8-A158-1126B61B473E}"/>
              </a:ext>
            </a:extLst>
          </p:cNvPr>
          <p:cNvSpPr/>
          <p:nvPr/>
        </p:nvSpPr>
        <p:spPr>
          <a:xfrm>
            <a:off x="396208" y="4104692"/>
            <a:ext cx="1493582" cy="238413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dirty="0">
                <a:solidFill>
                  <a:schemeClr val="tx1"/>
                </a:solidFill>
              </a:rPr>
              <a:t>Ever smoked vs never smoked 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(12 papers)</a:t>
            </a:r>
          </a:p>
          <a:p>
            <a:pPr algn="ctr"/>
            <a:endParaRPr lang="en-GB" sz="1400" dirty="0">
              <a:solidFill>
                <a:schemeClr val="tx1"/>
              </a:solidFill>
            </a:endParaRPr>
          </a:p>
          <a:p>
            <a:pPr algn="ctr"/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BD2901A-6CB7-4DE1-B97D-4E3F86A01FF6}"/>
              </a:ext>
            </a:extLst>
          </p:cNvPr>
          <p:cNvSpPr/>
          <p:nvPr/>
        </p:nvSpPr>
        <p:spPr>
          <a:xfrm>
            <a:off x="4750060" y="4104692"/>
            <a:ext cx="1812763" cy="238413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dirty="0">
                <a:solidFill>
                  <a:schemeClr val="tx1"/>
                </a:solidFill>
              </a:rPr>
              <a:t>Current smoker vs not currently smoking or never smoked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(10 papers)</a:t>
            </a:r>
          </a:p>
          <a:p>
            <a:pPr algn="ctr"/>
            <a:endParaRPr lang="en-GB" sz="1400" dirty="0">
              <a:solidFill>
                <a:schemeClr val="tx1"/>
              </a:solidFill>
            </a:endParaRPr>
          </a:p>
          <a:p>
            <a:pPr algn="ctr"/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3D9C2F0-54D0-4CA0-B038-0F55EAF6C30F}"/>
              </a:ext>
            </a:extLst>
          </p:cNvPr>
          <p:cNvSpPr/>
          <p:nvPr/>
        </p:nvSpPr>
        <p:spPr>
          <a:xfrm>
            <a:off x="2628431" y="2577194"/>
            <a:ext cx="1442982" cy="98744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chemeClr val="tx1"/>
                </a:solidFill>
              </a:rPr>
              <a:t>Outcomes covered by 3 or more papers 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DAD75789-B43C-4199-B163-F91CE51DCB22}"/>
              </a:ext>
            </a:extLst>
          </p:cNvPr>
          <p:cNvSpPr/>
          <p:nvPr/>
        </p:nvSpPr>
        <p:spPr>
          <a:xfrm>
            <a:off x="2817260" y="4109562"/>
            <a:ext cx="1150454" cy="238413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dirty="0">
                <a:solidFill>
                  <a:schemeClr val="tx1"/>
                </a:solidFill>
              </a:rPr>
              <a:t>Smoked in last 30 days?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(5 papers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How many ?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(3 papers)</a:t>
            </a:r>
          </a:p>
          <a:p>
            <a:pPr algn="ctr"/>
            <a:endParaRPr lang="en-GB" sz="1400" dirty="0">
              <a:solidFill>
                <a:schemeClr val="tx1"/>
              </a:solidFill>
            </a:endParaRPr>
          </a:p>
          <a:p>
            <a:pPr algn="ctr"/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5CC4B4F-7EC6-4C78-809F-E043721E9CC4}"/>
              </a:ext>
            </a:extLst>
          </p:cNvPr>
          <p:cNvSpPr/>
          <p:nvPr/>
        </p:nvSpPr>
        <p:spPr>
          <a:xfrm>
            <a:off x="2514540" y="6844408"/>
            <a:ext cx="1755895" cy="369354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b="1" dirty="0">
              <a:solidFill>
                <a:schemeClr val="tx1"/>
              </a:solidFill>
            </a:endParaRPr>
          </a:p>
          <a:p>
            <a:pPr algn="ctr"/>
            <a:endParaRPr lang="en-GB" sz="1400" b="1" dirty="0">
              <a:solidFill>
                <a:schemeClr val="tx1"/>
              </a:solidFill>
            </a:endParaRP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Age(3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Gender (5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Socio-economic status (4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Exposure to adverts (3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Liking product/advert (3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Having family who use (5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Having friends who use (4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Learning about smoking in school (4)</a:t>
            </a:r>
          </a:p>
          <a:p>
            <a:pPr algn="ctr"/>
            <a:endParaRPr lang="en-GB" sz="1400" b="1" dirty="0">
              <a:solidFill>
                <a:schemeClr val="tx1"/>
              </a:solidFill>
            </a:endParaRPr>
          </a:p>
          <a:p>
            <a:pPr algn="ctr"/>
            <a:endParaRPr lang="en-GB" sz="1400" dirty="0">
              <a:solidFill>
                <a:schemeClr val="tx1"/>
              </a:solidFill>
            </a:endParaRPr>
          </a:p>
          <a:p>
            <a:pPr algn="ctr"/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5C3A7A4-769E-4B5F-845E-057C9DC2A72D}"/>
              </a:ext>
            </a:extLst>
          </p:cNvPr>
          <p:cNvSpPr/>
          <p:nvPr/>
        </p:nvSpPr>
        <p:spPr>
          <a:xfrm>
            <a:off x="0" y="6844408"/>
            <a:ext cx="2285999" cy="369354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b="1" dirty="0">
              <a:solidFill>
                <a:schemeClr val="tx1"/>
              </a:solidFill>
            </a:endParaRPr>
          </a:p>
          <a:p>
            <a:pPr algn="ctr"/>
            <a:endParaRPr lang="en-GB" sz="1400" b="1" dirty="0">
              <a:solidFill>
                <a:schemeClr val="tx1"/>
              </a:solidFill>
            </a:endParaRP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Age(9)</a:t>
            </a:r>
          </a:p>
          <a:p>
            <a:pPr algn="ctr"/>
            <a:r>
              <a:rPr lang="en-GB" sz="1400" b="1" dirty="0">
                <a:solidFill>
                  <a:srgbClr val="FF0000"/>
                </a:solidFill>
              </a:rPr>
              <a:t>Gender (10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Socio-economic status (3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Exposure to adverts (6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Liking product/advert (6)</a:t>
            </a:r>
          </a:p>
          <a:p>
            <a:pPr algn="ctr"/>
            <a:r>
              <a:rPr lang="en-GB" sz="1400" b="1" dirty="0">
                <a:solidFill>
                  <a:srgbClr val="FF0000"/>
                </a:solidFill>
              </a:rPr>
              <a:t>Having family who use (8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Living with someone who smokes (5)</a:t>
            </a:r>
          </a:p>
          <a:p>
            <a:pPr algn="ctr"/>
            <a:r>
              <a:rPr lang="en-GB" sz="1400" b="1" dirty="0">
                <a:solidFill>
                  <a:srgbClr val="FF0000"/>
                </a:solidFill>
              </a:rPr>
              <a:t>Having friends who use (8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Learning about smoking in school (4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Ethnicity(3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Being a student(5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Beliefs (4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Attitude towards smoking (4)</a:t>
            </a:r>
          </a:p>
          <a:p>
            <a:pPr algn="ctr"/>
            <a:endParaRPr lang="en-GB" sz="1400" dirty="0">
              <a:solidFill>
                <a:schemeClr val="tx1"/>
              </a:solidFill>
            </a:endParaRPr>
          </a:p>
          <a:p>
            <a:pPr algn="ctr"/>
            <a:endParaRPr lang="en-GB" sz="1400" dirty="0">
              <a:solidFill>
                <a:schemeClr val="tx1"/>
              </a:solidFill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4C1C0DA-D80B-4F1E-B890-9540D0E2DC5B}"/>
              </a:ext>
            </a:extLst>
          </p:cNvPr>
          <p:cNvSpPr/>
          <p:nvPr/>
        </p:nvSpPr>
        <p:spPr>
          <a:xfrm>
            <a:off x="4470002" y="6844408"/>
            <a:ext cx="2285999" cy="369354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b="1" dirty="0">
                <a:solidFill>
                  <a:schemeClr val="tx1"/>
                </a:solidFill>
              </a:rPr>
              <a:t>Age(7)</a:t>
            </a:r>
          </a:p>
          <a:p>
            <a:pPr algn="ctr"/>
            <a:r>
              <a:rPr lang="en-GB" sz="1400" b="1" dirty="0">
                <a:solidFill>
                  <a:srgbClr val="FF0000"/>
                </a:solidFill>
              </a:rPr>
              <a:t>Gender (10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Socio-economic status (5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Exposure to adverts (8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Liking products/adverts (8)</a:t>
            </a:r>
          </a:p>
          <a:p>
            <a:pPr algn="ctr"/>
            <a:r>
              <a:rPr lang="en-GB" sz="1400" b="1" dirty="0">
                <a:solidFill>
                  <a:srgbClr val="FF0000"/>
                </a:solidFill>
              </a:rPr>
              <a:t>Having family who use (8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Having friends who use (8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Learning about smoking in school (7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Ethnicity(3)</a:t>
            </a:r>
          </a:p>
          <a:p>
            <a:pPr algn="ctr"/>
            <a:r>
              <a:rPr lang="en-GB" sz="1400" b="1" dirty="0">
                <a:solidFill>
                  <a:schemeClr val="tx1"/>
                </a:solidFill>
              </a:rPr>
              <a:t>Exposure to SHS (4)</a:t>
            </a:r>
          </a:p>
          <a:p>
            <a:pPr algn="ctr"/>
            <a:endParaRPr lang="en-GB" sz="1400" b="1" dirty="0">
              <a:solidFill>
                <a:schemeClr val="tx1"/>
              </a:solidFill>
            </a:endParaRPr>
          </a:p>
          <a:p>
            <a:pPr algn="ctr"/>
            <a:endParaRPr lang="en-GB" sz="1400" dirty="0">
              <a:solidFill>
                <a:schemeClr val="tx1"/>
              </a:solidFill>
            </a:endParaRPr>
          </a:p>
          <a:p>
            <a:pPr algn="ctr"/>
            <a:endParaRPr lang="en-GB" sz="1400" dirty="0">
              <a:solidFill>
                <a:schemeClr val="tx1"/>
              </a:solidFill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84ACCDE8-3DB1-49A0-A929-32A3E9049BBD}"/>
              </a:ext>
            </a:extLst>
          </p:cNvPr>
          <p:cNvCxnSpPr>
            <a:cxnSpLocks/>
          </p:cNvCxnSpPr>
          <p:nvPr/>
        </p:nvCxnSpPr>
        <p:spPr>
          <a:xfrm flipH="1" flipV="1">
            <a:off x="1270027" y="3928011"/>
            <a:ext cx="4244920" cy="692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4D759CC3-DD9B-421D-B5AA-9E4571336B9C}"/>
              </a:ext>
            </a:extLst>
          </p:cNvPr>
          <p:cNvCxnSpPr>
            <a:cxnSpLocks/>
            <a:endCxn id="10" idx="0"/>
          </p:cNvCxnSpPr>
          <p:nvPr/>
        </p:nvCxnSpPr>
        <p:spPr>
          <a:xfrm>
            <a:off x="3392487" y="3564641"/>
            <a:ext cx="0" cy="54492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F33D2D8-FA4E-4A03-B8C9-3CCDB59D883A}"/>
              </a:ext>
            </a:extLst>
          </p:cNvPr>
          <p:cNvCxnSpPr>
            <a:cxnSpLocks/>
          </p:cNvCxnSpPr>
          <p:nvPr/>
        </p:nvCxnSpPr>
        <p:spPr>
          <a:xfrm>
            <a:off x="5512921" y="3929188"/>
            <a:ext cx="0" cy="1707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5617964A-8333-4E3B-8CEC-99EB82197818}"/>
              </a:ext>
            </a:extLst>
          </p:cNvPr>
          <p:cNvCxnSpPr>
            <a:cxnSpLocks/>
          </p:cNvCxnSpPr>
          <p:nvPr/>
        </p:nvCxnSpPr>
        <p:spPr>
          <a:xfrm>
            <a:off x="1275778" y="3927029"/>
            <a:ext cx="0" cy="17766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818EA5D0-4052-557A-0080-AFB1B5E1D70E}"/>
              </a:ext>
            </a:extLst>
          </p:cNvPr>
          <p:cNvSpPr txBox="1"/>
          <p:nvPr/>
        </p:nvSpPr>
        <p:spPr>
          <a:xfrm>
            <a:off x="806824" y="508180"/>
            <a:ext cx="60943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3: Predictors of adolescent smoking mentioned across included studies 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A82CAE96-96ED-F5FC-F942-20A92DC09BA0}"/>
              </a:ext>
            </a:extLst>
          </p:cNvPr>
          <p:cNvCxnSpPr>
            <a:cxnSpLocks/>
          </p:cNvCxnSpPr>
          <p:nvPr/>
        </p:nvCxnSpPr>
        <p:spPr>
          <a:xfrm>
            <a:off x="3398009" y="2409976"/>
            <a:ext cx="0" cy="17073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012240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2</TotalTime>
  <Words>927</Words>
  <Application>Microsoft Macintosh PowerPoint</Application>
  <PresentationFormat>Widescreen</PresentationFormat>
  <Paragraphs>20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Newby (staff)</dc:creator>
  <cp:lastModifiedBy>Sandra Jumbe</cp:lastModifiedBy>
  <cp:revision>36</cp:revision>
  <dcterms:created xsi:type="dcterms:W3CDTF">2022-12-06T16:22:52Z</dcterms:created>
  <dcterms:modified xsi:type="dcterms:W3CDTF">2024-06-27T12:42:24Z</dcterms:modified>
</cp:coreProperties>
</file>